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>
      <p:cViewPr varScale="1">
        <p:scale>
          <a:sx n="107" d="100"/>
          <a:sy n="107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46A405-BC66-5049-AFBE-890596866F8C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6E3D68-7443-3549-91F0-B7882D23BF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078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6E3D68-7443-3549-91F0-B7882D23BF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0946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A0FAB-D162-0A08-CA52-C3D371A732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9E2420-FF4D-5EF9-2447-FB11DAEB34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FC0935-65BE-2B69-852F-3A67FC456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86E9BC-DF55-85C2-4A64-6620AB436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26FD21-96BA-2F7E-01A3-B3AAEB3C8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657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C66D8-7A2A-8BD8-4B26-B39F462E52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8B6A15-4DD7-2A3F-E948-85296DC463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59A0E4-3A8D-D0E7-FB08-09688098A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AE6D06-5C27-2D4A-77F3-EE7C62D59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31D95-BF7A-F09C-6646-F88265A1C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498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6E2FAE-B1FE-BC51-58DA-0250C08DB8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AD49D7-6A8C-3C7B-67B9-F476159C51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13DE1-E330-1DB6-D305-93F568223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4E2E10-F0E2-7EE8-C9DE-4D00C0506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FFDF96-E187-4FFA-1CC0-754F0BBDB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811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E8956F-1064-31E3-6F68-916B3005D2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67F3D7-1949-ACF0-CE89-CF66D01F97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EA6B5B-F7BD-42AA-8808-D46F92796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0A510D-1620-50AE-3A21-259A15A38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05C124-5800-F1C3-74C5-FA5B654FD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29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7D1FD-61FA-582E-78F7-E760B24EB9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722381-FE93-EF87-BDDD-00AB426A1A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ECD5B7-9A16-3D96-068E-D18E1B342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3CAFEF-C8D8-8A68-A3E0-88CFAF155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B4E015-269A-2224-751A-9DE927AC51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681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4336F-2A8B-1C44-DCDC-E10EC97940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F61364-887D-19B7-9070-ED27F30B74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3D400C-1A35-D7E9-C072-A5F1D0647C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3A5B6C-1F0F-D00E-E34C-2FB8ECD85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C70C59-4654-8884-4DE3-06032DCA8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EC7574-B9B2-8694-38DA-F982F2BAD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071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3CB53-CDE2-EFD4-845E-1A8787ACFF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97C208-E961-50A7-76AE-367C36DBE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269891-4DED-6A4A-340F-E205EDDC60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F772FD-12F2-5C32-6F68-1C961967A4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458929-D5B4-4C35-146D-D04A1979AF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854564-CBF2-53F6-57FD-C9B658DD1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9ED42F-C423-7465-FAA4-E4E8D7347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450D797-B1FF-0CE7-009A-0741A1221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543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0A4A80-AE24-FAF9-146F-E5FE99B1EA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FD02B0-407F-C6F4-80F4-680170CE1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D9DDBA-3727-E18E-9FEE-BCE609E59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2B6B17-5478-DD29-B62B-E6A0B6A4F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86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D0B5E5-E563-7684-B165-631FBC956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52F7FB-797F-41FC-554D-2D5DAF1B0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8BA2A0-FCF9-E03D-DBC0-ADDB0E367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307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3D6BA7-0503-5D7D-4302-5EE8D13F13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505076-12F5-86FF-981D-C3741E4122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301AC6-BB31-81B2-2416-0651BF1C5A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B4B492-58EB-C8B1-CC50-E36E8615B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4C269C-2C65-617D-199B-37B0DDCAD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AB2FA6-57A1-E31B-A13F-116FE5D41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892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2E3FF-BC34-F2A0-B0AA-BF98E8235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58BCEE-A6AF-8940-D76D-884A67A517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31323E-6677-89E6-D7DF-211ED3B623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7C6073-A5BD-A7EB-B513-617D0C0BB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BF025F-1F2A-96E7-5F12-EA26063E9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B2C95A-3ADF-69A2-83AE-802E4D57C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799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B7D85D-3E52-74CD-02C1-8ADB9E2772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5EAB15-1D42-DA0B-9E92-D5440D5466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E60111-D5A9-A84B-17C8-D73DA6F996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4C29AD-8520-6545-A257-6AE14FF3B545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F8CC71-C3A9-1581-1E57-41EE8E9806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7F6A33-2A81-D9F7-6472-CCFB9E2972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04A1B-C0E6-0040-A201-6FBE01D6BB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639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17671A1-A36A-1075-CED8-ECFE9413718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  <a:lum bright="20000" contrast="40000"/>
          </a:blip>
          <a:srcRect l="66329" t="3035"/>
          <a:stretch/>
        </p:blipFill>
        <p:spPr>
          <a:xfrm rot="16200000">
            <a:off x="7423266" y="-2269933"/>
            <a:ext cx="1661123" cy="712417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E65F88B-5111-62FF-012A-BAD6F0E06BEE}"/>
              </a:ext>
            </a:extLst>
          </p:cNvPr>
          <p:cNvSpPr txBox="1"/>
          <p:nvPr/>
        </p:nvSpPr>
        <p:spPr>
          <a:xfrm>
            <a:off x="2253342" y="1371600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A</a:t>
            </a:r>
          </a:p>
        </p:txBody>
      </p:sp>
      <p:pic>
        <p:nvPicPr>
          <p:cNvPr id="6" name="Picture 5" descr="A picture containing text, outdoor, slope, day&#10;&#10;Description automatically generated">
            <a:extLst>
              <a:ext uri="{FF2B5EF4-FFF2-40B4-BE49-F238E27FC236}">
                <a16:creationId xmlns:a16="http://schemas.microsoft.com/office/drawing/2014/main" id="{8CB450FC-EAF4-6423-75C8-F2776A0D4CF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265" r="915"/>
          <a:stretch/>
        </p:blipFill>
        <p:spPr>
          <a:xfrm rot="16200000" flipH="1">
            <a:off x="6966342" y="599854"/>
            <a:ext cx="2590179" cy="713937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33FCC82-06C2-1793-F8E3-C9FC0B32AFCD}"/>
              </a:ext>
            </a:extLst>
          </p:cNvPr>
          <p:cNvSpPr txBox="1"/>
          <p:nvPr/>
        </p:nvSpPr>
        <p:spPr>
          <a:xfrm>
            <a:off x="6596742" y="2776479"/>
            <a:ext cx="953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UCCT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730A6D1-9AFB-06FF-D7C9-1B99F0BD32C5}"/>
              </a:ext>
            </a:extLst>
          </p:cNvPr>
          <p:cNvSpPr txBox="1"/>
          <p:nvPr/>
        </p:nvSpPr>
        <p:spPr>
          <a:xfrm>
            <a:off x="6318933" y="3136183"/>
            <a:ext cx="6644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GF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B11A0D1-0F8C-3FCD-2F61-513171CAF8F1}"/>
              </a:ext>
            </a:extLst>
          </p:cNvPr>
          <p:cNvSpPr txBox="1"/>
          <p:nvPr/>
        </p:nvSpPr>
        <p:spPr>
          <a:xfrm>
            <a:off x="7223292" y="3147228"/>
            <a:ext cx="654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BX3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0E87E7B-9BC9-0E2B-3FA4-B12B38CD048A}"/>
              </a:ext>
            </a:extLst>
          </p:cNvPr>
          <p:cNvCxnSpPr/>
          <p:nvPr/>
        </p:nvCxnSpPr>
        <p:spPr>
          <a:xfrm>
            <a:off x="6264503" y="3516242"/>
            <a:ext cx="8090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F5CDBAD-88F3-BAAB-9DC7-BC7C0527A0DA}"/>
              </a:ext>
            </a:extLst>
          </p:cNvPr>
          <p:cNvCxnSpPr/>
          <p:nvPr/>
        </p:nvCxnSpPr>
        <p:spPr>
          <a:xfrm>
            <a:off x="7223292" y="3516401"/>
            <a:ext cx="8090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C682B472-BA04-B178-29AE-D3D3774367D4}"/>
              </a:ext>
            </a:extLst>
          </p:cNvPr>
          <p:cNvSpPr txBox="1"/>
          <p:nvPr/>
        </p:nvSpPr>
        <p:spPr>
          <a:xfrm>
            <a:off x="8862889" y="2786892"/>
            <a:ext cx="953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UCCT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5CC38CE-5A29-A6F8-FF93-92DED301905B}"/>
              </a:ext>
            </a:extLst>
          </p:cNvPr>
          <p:cNvSpPr txBox="1"/>
          <p:nvPr/>
        </p:nvSpPr>
        <p:spPr>
          <a:xfrm>
            <a:off x="8585080" y="3146596"/>
            <a:ext cx="6644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GF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C3A9089-066B-368A-A8F1-2C94D7BE3CC7}"/>
              </a:ext>
            </a:extLst>
          </p:cNvPr>
          <p:cNvSpPr txBox="1"/>
          <p:nvPr/>
        </p:nvSpPr>
        <p:spPr>
          <a:xfrm>
            <a:off x="9489439" y="3157641"/>
            <a:ext cx="654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BX3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1DABD878-678F-DD17-D069-2C3A20F584E7}"/>
              </a:ext>
            </a:extLst>
          </p:cNvPr>
          <p:cNvCxnSpPr/>
          <p:nvPr/>
        </p:nvCxnSpPr>
        <p:spPr>
          <a:xfrm>
            <a:off x="8530650" y="3526655"/>
            <a:ext cx="8090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C542BDA6-AB2D-8993-15BC-783E6578B7A3}"/>
              </a:ext>
            </a:extLst>
          </p:cNvPr>
          <p:cNvCxnSpPr/>
          <p:nvPr/>
        </p:nvCxnSpPr>
        <p:spPr>
          <a:xfrm>
            <a:off x="9489439" y="3526814"/>
            <a:ext cx="8090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90715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F827027-00EA-000D-1B7F-04B3AEE67A3F}"/>
              </a:ext>
            </a:extLst>
          </p:cNvPr>
          <p:cNvSpPr txBox="1"/>
          <p:nvPr/>
        </p:nvSpPr>
        <p:spPr>
          <a:xfrm>
            <a:off x="149066" y="554979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2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5C5530D-7796-F95D-0AF2-CC54A1C3B11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20" t="5397" r="49716" b="72857"/>
          <a:stretch/>
        </p:blipFill>
        <p:spPr>
          <a:xfrm>
            <a:off x="1385572" y="662701"/>
            <a:ext cx="4155250" cy="24601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2CF8808-8BE5-6ACA-63A5-4A657E333714}"/>
              </a:ext>
            </a:extLst>
          </p:cNvPr>
          <p:cNvSpPr txBox="1"/>
          <p:nvPr/>
        </p:nvSpPr>
        <p:spPr>
          <a:xfrm>
            <a:off x="2090228" y="151852"/>
            <a:ext cx="2663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kt/FBXW7△F iCCA mode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6BA0C5D-ECE2-A69B-9528-1C20767F193B}"/>
              </a:ext>
            </a:extLst>
          </p:cNvPr>
          <p:cNvSpPr txBox="1"/>
          <p:nvPr/>
        </p:nvSpPr>
        <p:spPr>
          <a:xfrm>
            <a:off x="3146142" y="379319"/>
            <a:ext cx="7248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umor</a:t>
            </a:r>
          </a:p>
          <a:p>
            <a:r>
              <a:rPr lang="en-US" sz="1400" dirty="0"/>
              <a:t>Contr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886AD8-5B6D-550A-1C2C-285C8DD0D762}"/>
              </a:ext>
            </a:extLst>
          </p:cNvPr>
          <p:cNvSpPr txBox="1"/>
          <p:nvPr/>
        </p:nvSpPr>
        <p:spPr>
          <a:xfrm>
            <a:off x="3819801" y="379319"/>
            <a:ext cx="12877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TBX3</a:t>
            </a:r>
          </a:p>
          <a:p>
            <a:pPr algn="ctr"/>
            <a:r>
              <a:rPr lang="en-US" sz="1400" dirty="0"/>
              <a:t>overexpression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691B4127-B240-5253-99BD-9236ED62DC20}"/>
              </a:ext>
            </a:extLst>
          </p:cNvPr>
          <p:cNvCxnSpPr/>
          <p:nvPr/>
        </p:nvCxnSpPr>
        <p:spPr>
          <a:xfrm flipV="1">
            <a:off x="4093197" y="804565"/>
            <a:ext cx="108857" cy="1092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0F20B7B0-C0FE-3E29-41AE-CF39DDD3FD48}"/>
              </a:ext>
            </a:extLst>
          </p:cNvPr>
          <p:cNvCxnSpPr>
            <a:cxnSpLocks/>
          </p:cNvCxnSpPr>
          <p:nvPr/>
        </p:nvCxnSpPr>
        <p:spPr>
          <a:xfrm>
            <a:off x="3146142" y="924311"/>
            <a:ext cx="5334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AFE6993-FAE1-3905-1BD8-59B212DCCD8E}"/>
              </a:ext>
            </a:extLst>
          </p:cNvPr>
          <p:cNvCxnSpPr>
            <a:cxnSpLocks/>
          </p:cNvCxnSpPr>
          <p:nvPr/>
        </p:nvCxnSpPr>
        <p:spPr>
          <a:xfrm>
            <a:off x="3808915" y="934926"/>
            <a:ext cx="5434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34C1140C-B0C4-CD4D-3E53-C36C85627943}"/>
              </a:ext>
            </a:extLst>
          </p:cNvPr>
          <p:cNvSpPr txBox="1"/>
          <p:nvPr/>
        </p:nvSpPr>
        <p:spPr>
          <a:xfrm>
            <a:off x="2310176" y="390632"/>
            <a:ext cx="76815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Normal </a:t>
            </a:r>
          </a:p>
          <a:p>
            <a:pPr algn="ctr"/>
            <a:r>
              <a:rPr lang="en-US" sz="1400" dirty="0"/>
              <a:t>liver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299F333-6C73-2CBF-6E3D-76DA101B46E2}"/>
              </a:ext>
            </a:extLst>
          </p:cNvPr>
          <p:cNvCxnSpPr>
            <a:cxnSpLocks/>
          </p:cNvCxnSpPr>
          <p:nvPr/>
        </p:nvCxnSpPr>
        <p:spPr>
          <a:xfrm>
            <a:off x="2188199" y="924311"/>
            <a:ext cx="885311" cy="1061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6" name="Picture 75">
            <a:extLst>
              <a:ext uri="{FF2B5EF4-FFF2-40B4-BE49-F238E27FC236}">
                <a16:creationId xmlns:a16="http://schemas.microsoft.com/office/drawing/2014/main" id="{CFDEB685-4136-869E-41B0-17A8909D1C4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447" t="5397" r="4605" b="72857"/>
          <a:stretch/>
        </p:blipFill>
        <p:spPr>
          <a:xfrm>
            <a:off x="1460401" y="3143947"/>
            <a:ext cx="3775825" cy="2460172"/>
          </a:xfrm>
          <a:prstGeom prst="rect">
            <a:avLst/>
          </a:prstGeom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C080E19A-8027-CABF-FE72-85078D5FD798}"/>
              </a:ext>
            </a:extLst>
          </p:cNvPr>
          <p:cNvSpPr txBox="1"/>
          <p:nvPr/>
        </p:nvSpPr>
        <p:spPr>
          <a:xfrm>
            <a:off x="5107526" y="5032836"/>
            <a:ext cx="7184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1638518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CDD2067C-EBB0-9671-8A7D-E3984C459323}"/>
              </a:ext>
            </a:extLst>
          </p:cNvPr>
          <p:cNvSpPr txBox="1"/>
          <p:nvPr/>
        </p:nvSpPr>
        <p:spPr>
          <a:xfrm>
            <a:off x="433366" y="600853"/>
            <a:ext cx="2476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.</a:t>
            </a:r>
          </a:p>
        </p:txBody>
      </p:sp>
      <p:pic>
        <p:nvPicPr>
          <p:cNvPr id="14" name="Picture 13" descr="A red surface with a red background&#10;&#10;Description automatically generated">
            <a:extLst>
              <a:ext uri="{FF2B5EF4-FFF2-40B4-BE49-F238E27FC236}">
                <a16:creationId xmlns:a16="http://schemas.microsoft.com/office/drawing/2014/main" id="{8449EBD6-1533-05DA-F0E4-B7654D98F3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273" t="79018" r="36531" b="2806"/>
          <a:stretch/>
        </p:blipFill>
        <p:spPr>
          <a:xfrm>
            <a:off x="1712310" y="2193643"/>
            <a:ext cx="2580085" cy="106421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0E5FE34-6C8B-E4A2-A328-7E035F5AEB27}"/>
              </a:ext>
            </a:extLst>
          </p:cNvPr>
          <p:cNvSpPr txBox="1"/>
          <p:nvPr/>
        </p:nvSpPr>
        <p:spPr>
          <a:xfrm>
            <a:off x="1065978" y="2750437"/>
            <a:ext cx="6463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37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0DF849F-4735-723F-5F5F-A1330287904D}"/>
              </a:ext>
            </a:extLst>
          </p:cNvPr>
          <p:cNvSpPr txBox="1"/>
          <p:nvPr/>
        </p:nvSpPr>
        <p:spPr>
          <a:xfrm>
            <a:off x="1065978" y="2348134"/>
            <a:ext cx="6463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50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9DD6C92-FF69-F794-8AEA-307A7DB9DFAA}"/>
              </a:ext>
            </a:extLst>
          </p:cNvPr>
          <p:cNvSpPr txBox="1"/>
          <p:nvPr/>
        </p:nvSpPr>
        <p:spPr>
          <a:xfrm>
            <a:off x="4292395" y="2403731"/>
            <a:ext cx="6463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25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5BFBC91-1102-55A5-4C28-19D987838A69}"/>
              </a:ext>
            </a:extLst>
          </p:cNvPr>
          <p:cNvSpPr txBox="1"/>
          <p:nvPr/>
        </p:nvSpPr>
        <p:spPr>
          <a:xfrm>
            <a:off x="2117453" y="3247439"/>
            <a:ext cx="707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𝛽-act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3B964F7-71FF-07AF-9625-36F6ECC9B4BA}"/>
              </a:ext>
            </a:extLst>
          </p:cNvPr>
          <p:cNvSpPr txBox="1"/>
          <p:nvPr/>
        </p:nvSpPr>
        <p:spPr>
          <a:xfrm>
            <a:off x="2990217" y="1083177"/>
            <a:ext cx="546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B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7AAD70-5D2A-B06D-E3A7-1D75FCD304CF}"/>
              </a:ext>
            </a:extLst>
          </p:cNvPr>
          <p:cNvSpPr txBox="1"/>
          <p:nvPr/>
        </p:nvSpPr>
        <p:spPr>
          <a:xfrm rot="18735191">
            <a:off x="2114285" y="1790189"/>
            <a:ext cx="714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gEGFP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D1CD75E-D169-60A8-64FB-B07F8CFFE674}"/>
              </a:ext>
            </a:extLst>
          </p:cNvPr>
          <p:cNvSpPr txBox="1"/>
          <p:nvPr/>
        </p:nvSpPr>
        <p:spPr>
          <a:xfrm rot="18735191">
            <a:off x="2341233" y="1706422"/>
            <a:ext cx="9669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gMAD2L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1651E1B-5108-9ABE-2A71-655260E3BD94}"/>
              </a:ext>
            </a:extLst>
          </p:cNvPr>
          <p:cNvSpPr txBox="1"/>
          <p:nvPr/>
        </p:nvSpPr>
        <p:spPr>
          <a:xfrm>
            <a:off x="7224320" y="1083381"/>
            <a:ext cx="1118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UCCT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D52CE0A-81F4-8AE4-4F35-091B15E02EBA}"/>
              </a:ext>
            </a:extLst>
          </p:cNvPr>
          <p:cNvSpPr txBox="1"/>
          <p:nvPr/>
        </p:nvSpPr>
        <p:spPr>
          <a:xfrm rot="18735191">
            <a:off x="7095354" y="1635475"/>
            <a:ext cx="7147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gEGFP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50AF55B-087E-23B9-B2C2-9672040D1681}"/>
              </a:ext>
            </a:extLst>
          </p:cNvPr>
          <p:cNvSpPr txBox="1"/>
          <p:nvPr/>
        </p:nvSpPr>
        <p:spPr>
          <a:xfrm rot="18735191">
            <a:off x="7322302" y="1551708"/>
            <a:ext cx="9669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gMAD2L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AEF5302-4EF2-5D9F-B1C2-ECD177F4EB38}"/>
              </a:ext>
            </a:extLst>
          </p:cNvPr>
          <p:cNvSpPr txBox="1"/>
          <p:nvPr/>
        </p:nvSpPr>
        <p:spPr>
          <a:xfrm>
            <a:off x="3263690" y="3257859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MAD2L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EF4DADD-63E1-E5FC-7C2B-18866970E4D6}"/>
              </a:ext>
            </a:extLst>
          </p:cNvPr>
          <p:cNvSpPr txBox="1"/>
          <p:nvPr/>
        </p:nvSpPr>
        <p:spPr>
          <a:xfrm rot="18735191">
            <a:off x="3285446" y="1752955"/>
            <a:ext cx="714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gEGFP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BED6015-0E08-1F46-39A7-78CDCDBA8EBA}"/>
              </a:ext>
            </a:extLst>
          </p:cNvPr>
          <p:cNvSpPr txBox="1"/>
          <p:nvPr/>
        </p:nvSpPr>
        <p:spPr>
          <a:xfrm rot="18735191">
            <a:off x="3512394" y="1669188"/>
            <a:ext cx="9669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gMAD2L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23193FF-BC69-F94E-7FD8-A75A6C08E438}"/>
              </a:ext>
            </a:extLst>
          </p:cNvPr>
          <p:cNvSpPr txBox="1"/>
          <p:nvPr/>
        </p:nvSpPr>
        <p:spPr>
          <a:xfrm>
            <a:off x="6202661" y="2743226"/>
            <a:ext cx="6463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37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5B3932D-C859-7AA1-9232-C90CA3E5E54A}"/>
              </a:ext>
            </a:extLst>
          </p:cNvPr>
          <p:cNvSpPr txBox="1"/>
          <p:nvPr/>
        </p:nvSpPr>
        <p:spPr>
          <a:xfrm>
            <a:off x="6202661" y="2340923"/>
            <a:ext cx="6463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50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0A305AC-8B63-97E2-3867-2F8DA814F80E}"/>
              </a:ext>
            </a:extLst>
          </p:cNvPr>
          <p:cNvSpPr txBox="1"/>
          <p:nvPr/>
        </p:nvSpPr>
        <p:spPr>
          <a:xfrm>
            <a:off x="7090847" y="3251115"/>
            <a:ext cx="707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𝛽-actin</a:t>
            </a:r>
          </a:p>
        </p:txBody>
      </p:sp>
      <p:pic>
        <p:nvPicPr>
          <p:cNvPr id="37" name="Picture 36" descr="A red wall with green lights&#10;&#10;Description automatically generated">
            <a:extLst>
              <a:ext uri="{FF2B5EF4-FFF2-40B4-BE49-F238E27FC236}">
                <a16:creationId xmlns:a16="http://schemas.microsoft.com/office/drawing/2014/main" id="{1B818DB7-0219-1066-0F81-D0CF5EF7DD6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199" t="73482" r="25763" b="5552"/>
          <a:stretch/>
        </p:blipFill>
        <p:spPr>
          <a:xfrm>
            <a:off x="6872480" y="2061597"/>
            <a:ext cx="3500514" cy="1227524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092DFECE-6B21-FC29-1BC3-216EAFE2BF4A}"/>
              </a:ext>
            </a:extLst>
          </p:cNvPr>
          <p:cNvSpPr txBox="1"/>
          <p:nvPr/>
        </p:nvSpPr>
        <p:spPr>
          <a:xfrm>
            <a:off x="8998724" y="1073818"/>
            <a:ext cx="1118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UCCT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442C315-FDC6-32A6-0AD1-917EA208A056}"/>
              </a:ext>
            </a:extLst>
          </p:cNvPr>
          <p:cNvSpPr txBox="1"/>
          <p:nvPr/>
        </p:nvSpPr>
        <p:spPr>
          <a:xfrm rot="18735191">
            <a:off x="8869758" y="1625912"/>
            <a:ext cx="7147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gEGFP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4BE0513-5383-E852-6030-2002CBC19661}"/>
              </a:ext>
            </a:extLst>
          </p:cNvPr>
          <p:cNvSpPr txBox="1"/>
          <p:nvPr/>
        </p:nvSpPr>
        <p:spPr>
          <a:xfrm rot="18735191">
            <a:off x="9096706" y="1542145"/>
            <a:ext cx="9669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gMAD2L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A7D19D1-CFBA-5EC2-08F5-7E93FF123B02}"/>
              </a:ext>
            </a:extLst>
          </p:cNvPr>
          <p:cNvSpPr txBox="1"/>
          <p:nvPr/>
        </p:nvSpPr>
        <p:spPr>
          <a:xfrm>
            <a:off x="10372994" y="2288747"/>
            <a:ext cx="6463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25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CAB6401-C5B8-3183-167B-6956C289EFA7}"/>
              </a:ext>
            </a:extLst>
          </p:cNvPr>
          <p:cNvSpPr txBox="1"/>
          <p:nvPr/>
        </p:nvSpPr>
        <p:spPr>
          <a:xfrm>
            <a:off x="8768730" y="3289121"/>
            <a:ext cx="8114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MAD2L1</a:t>
            </a:r>
          </a:p>
        </p:txBody>
      </p:sp>
    </p:spTree>
    <p:extLst>
      <p:ext uri="{BB962C8B-B14F-4D97-AF65-F5344CB8AC3E}">
        <p14:creationId xmlns:p14="http://schemas.microsoft.com/office/powerpoint/2010/main" val="1446370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1</TotalTime>
  <Words>54</Words>
  <Application>Microsoft Office PowerPoint</Application>
  <PresentationFormat>Widescreen</PresentationFormat>
  <Paragraphs>39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g, Shanshan</dc:creator>
  <cp:lastModifiedBy>Chen lab</cp:lastModifiedBy>
  <cp:revision>13</cp:revision>
  <dcterms:created xsi:type="dcterms:W3CDTF">2023-11-08T06:04:11Z</dcterms:created>
  <dcterms:modified xsi:type="dcterms:W3CDTF">2024-04-21T04:45:04Z</dcterms:modified>
</cp:coreProperties>
</file>